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705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452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2607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4058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9519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368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173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3501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72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035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993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A870F-8CED-4AF5-99CB-D02FCA31B342}" type="datetimeFigureOut">
              <a:rPr lang="en-GB" smtClean="0"/>
              <a:pPr/>
              <a:t>10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A8960-07F4-4209-8CF9-799B922CE7C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479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79512" y="116632"/>
            <a:ext cx="69847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Gill Sans MT" pitchFamily="34" charset="0"/>
              </a:rPr>
              <a:t>FIGURE S1</a:t>
            </a:r>
          </a:p>
          <a:p>
            <a:r>
              <a:rPr lang="en-GB" sz="1200" b="1" dirty="0" smtClean="0">
                <a:latin typeface="Gill Sans MT" pitchFamily="34" charset="0"/>
              </a:rPr>
              <a:t>Metabolite content of  CVF of pregnant women in relation to delivery outcome</a:t>
            </a:r>
            <a:endParaRPr lang="en-GB" sz="1200" b="1" dirty="0">
              <a:latin typeface="Gill Sans MT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59298" y="131057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 ALR20-22,pre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59297" y="203065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AHR20-22,pre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65209" y="167061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      ALR20-22,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65209" y="239069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      AHR20-22,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65209" y="275073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AHR26-28,pre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39552" y="3110771"/>
            <a:ext cx="145990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       AHR26-28,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65209" y="347081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 SYM24-36,preterm</a:t>
            </a:r>
            <a:endParaRPr lang="en-GB" sz="1000" b="1" dirty="0">
              <a:latin typeface="Gill Sans MT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65209" y="3830851"/>
            <a:ext cx="14342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Gill Sans MT" pitchFamily="34" charset="0"/>
              </a:rPr>
              <a:t>         SYM24-36,term</a:t>
            </a:r>
            <a:endParaRPr lang="en-GB" sz="1000" b="1" dirty="0">
              <a:latin typeface="Gill Sans MT" pitchFamily="34" charset="0"/>
            </a:endParaRPr>
          </a:p>
        </p:txBody>
      </p:sp>
      <p:pic>
        <p:nvPicPr>
          <p:cNvPr id="2" name="Picture 2" descr="C:\Users\UOS\Downloads\heatMapUse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76"/>
          <a:stretch/>
        </p:blipFill>
        <p:spPr bwMode="auto">
          <a:xfrm>
            <a:off x="1907704" y="980728"/>
            <a:ext cx="5040560" cy="381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77509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30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OS</dc:creator>
  <cp:lastModifiedBy>UOS</cp:lastModifiedBy>
  <cp:revision>6</cp:revision>
  <dcterms:created xsi:type="dcterms:W3CDTF">2015-07-04T10:45:58Z</dcterms:created>
  <dcterms:modified xsi:type="dcterms:W3CDTF">2015-07-10T09:32:05Z</dcterms:modified>
</cp:coreProperties>
</file>